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40" d="100"/>
          <a:sy n="40" d="100"/>
        </p:scale>
        <p:origin x="2484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paper\new%20results%2015%20d\FC%20PFD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65410319663296"/>
          <c:y val="4.6276355644380526E-2"/>
          <c:w val="0.85472996709438886"/>
          <c:h val="0.70326340326340331"/>
        </c:manualLayout>
      </c:layout>
      <c:lineChart>
        <c:grouping val="standard"/>
        <c:varyColors val="0"/>
        <c:ser>
          <c:idx val="0"/>
          <c:order val="0"/>
          <c:tx>
            <c:strRef>
              <c:f>Sheet1!$AE$6</c:f>
              <c:strCache>
                <c:ptCount val="1"/>
                <c:pt idx="0">
                  <c:v>Rs + Drough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F$8:$AM$8</c:f>
                <c:numCache>
                  <c:formatCode>General</c:formatCode>
                  <c:ptCount val="8"/>
                  <c:pt idx="0">
                    <c:v>0.69531135923090304</c:v>
                  </c:pt>
                  <c:pt idx="1">
                    <c:v>0.61608815639742986</c:v>
                  </c:pt>
                  <c:pt idx="2">
                    <c:v>1.2655003525106223</c:v>
                  </c:pt>
                  <c:pt idx="3">
                    <c:v>2.2842253162122841</c:v>
                  </c:pt>
                  <c:pt idx="4">
                    <c:v>2.6566254376342622</c:v>
                  </c:pt>
                  <c:pt idx="5">
                    <c:v>2.4575163501170567</c:v>
                  </c:pt>
                  <c:pt idx="6">
                    <c:v>2.2076093039617852</c:v>
                  </c:pt>
                  <c:pt idx="7">
                    <c:v>1.9240031289190078</c:v>
                  </c:pt>
                </c:numCache>
              </c:numRef>
            </c:plus>
            <c:minus>
              <c:numRef>
                <c:f>Sheet1!$AF$8:$AM$8</c:f>
                <c:numCache>
                  <c:formatCode>General</c:formatCode>
                  <c:ptCount val="8"/>
                  <c:pt idx="0">
                    <c:v>0.69531135923090304</c:v>
                  </c:pt>
                  <c:pt idx="1">
                    <c:v>0.61608815639742986</c:v>
                  </c:pt>
                  <c:pt idx="2">
                    <c:v>1.2655003525106223</c:v>
                  </c:pt>
                  <c:pt idx="3">
                    <c:v>2.2842253162122841</c:v>
                  </c:pt>
                  <c:pt idx="4">
                    <c:v>2.6566254376342622</c:v>
                  </c:pt>
                  <c:pt idx="5">
                    <c:v>2.4575163501170567</c:v>
                  </c:pt>
                  <c:pt idx="6">
                    <c:v>2.2076093039617852</c:v>
                  </c:pt>
                  <c:pt idx="7">
                    <c:v>1.92400312891900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F$2:$AM$2</c:f>
              <c:strCache>
                <c:ptCount val="8"/>
                <c:pt idx="0">
                  <c:v>0 D</c:v>
                </c:pt>
                <c:pt idx="1">
                  <c:v>2 D</c:v>
                </c:pt>
                <c:pt idx="2">
                  <c:v>3 D</c:v>
                </c:pt>
                <c:pt idx="3">
                  <c:v>4 D</c:v>
                </c:pt>
                <c:pt idx="4">
                  <c:v>6 D</c:v>
                </c:pt>
                <c:pt idx="5">
                  <c:v>7 D</c:v>
                </c:pt>
                <c:pt idx="6">
                  <c:v>8 D</c:v>
                </c:pt>
                <c:pt idx="7">
                  <c:v>10 D</c:v>
                </c:pt>
              </c:strCache>
            </c:strRef>
          </c:cat>
          <c:val>
            <c:numRef>
              <c:f>Sheet1!$AF$6:$AM$6</c:f>
              <c:numCache>
                <c:formatCode>General</c:formatCode>
                <c:ptCount val="8"/>
                <c:pt idx="0">
                  <c:v>89.723032069970827</c:v>
                </c:pt>
                <c:pt idx="1">
                  <c:v>80.636540330417873</c:v>
                </c:pt>
                <c:pt idx="2">
                  <c:v>71.37998056365403</c:v>
                </c:pt>
                <c:pt idx="3">
                  <c:v>61.054421768707471</c:v>
                </c:pt>
                <c:pt idx="4">
                  <c:v>47.035957240038869</c:v>
                </c:pt>
                <c:pt idx="5">
                  <c:v>42.517006802721085</c:v>
                </c:pt>
                <c:pt idx="6">
                  <c:v>37.463556851311949</c:v>
                </c:pt>
                <c:pt idx="7">
                  <c:v>29.64042759961126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E$12</c:f>
              <c:strCache>
                <c:ptCount val="1"/>
                <c:pt idx="0">
                  <c:v>Psp + Drought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F$14:$AM$14</c:f>
                <c:numCache>
                  <c:formatCode>General</c:formatCode>
                  <c:ptCount val="8"/>
                  <c:pt idx="0">
                    <c:v>0.9337435637102881</c:v>
                  </c:pt>
                  <c:pt idx="1">
                    <c:v>0.55029562003102339</c:v>
                  </c:pt>
                  <c:pt idx="2">
                    <c:v>1.2314574932998836</c:v>
                  </c:pt>
                  <c:pt idx="3">
                    <c:v>1.2485949503359652</c:v>
                  </c:pt>
                  <c:pt idx="4">
                    <c:v>0.75903583932407637</c:v>
                  </c:pt>
                  <c:pt idx="5">
                    <c:v>0.77176122827600602</c:v>
                  </c:pt>
                  <c:pt idx="6">
                    <c:v>0.41446118854305469</c:v>
                  </c:pt>
                  <c:pt idx="7">
                    <c:v>1.4009840741082362</c:v>
                  </c:pt>
                </c:numCache>
              </c:numRef>
            </c:plus>
            <c:minus>
              <c:numRef>
                <c:f>Sheet1!$AF$14:$AM$14</c:f>
                <c:numCache>
                  <c:formatCode>General</c:formatCode>
                  <c:ptCount val="8"/>
                  <c:pt idx="0">
                    <c:v>0.9337435637102881</c:v>
                  </c:pt>
                  <c:pt idx="1">
                    <c:v>0.55029562003102339</c:v>
                  </c:pt>
                  <c:pt idx="2">
                    <c:v>1.2314574932998836</c:v>
                  </c:pt>
                  <c:pt idx="3">
                    <c:v>1.2485949503359652</c:v>
                  </c:pt>
                  <c:pt idx="4">
                    <c:v>0.75903583932407637</c:v>
                  </c:pt>
                  <c:pt idx="5">
                    <c:v>0.77176122827600602</c:v>
                  </c:pt>
                  <c:pt idx="6">
                    <c:v>0.41446118854305469</c:v>
                  </c:pt>
                  <c:pt idx="7">
                    <c:v>1.40098407410823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F$2:$AM$2</c:f>
              <c:strCache>
                <c:ptCount val="8"/>
                <c:pt idx="0">
                  <c:v>0 D</c:v>
                </c:pt>
                <c:pt idx="1">
                  <c:v>2 D</c:v>
                </c:pt>
                <c:pt idx="2">
                  <c:v>3 D</c:v>
                </c:pt>
                <c:pt idx="3">
                  <c:v>4 D</c:v>
                </c:pt>
                <c:pt idx="4">
                  <c:v>6 D</c:v>
                </c:pt>
                <c:pt idx="5">
                  <c:v>7 D</c:v>
                </c:pt>
                <c:pt idx="6">
                  <c:v>8 D</c:v>
                </c:pt>
                <c:pt idx="7">
                  <c:v>10 D</c:v>
                </c:pt>
              </c:strCache>
            </c:strRef>
          </c:cat>
          <c:val>
            <c:numRef>
              <c:f>Sheet1!$AF$12:$AM$12</c:f>
              <c:numCache>
                <c:formatCode>General</c:formatCode>
                <c:ptCount val="8"/>
                <c:pt idx="0">
                  <c:v>85.738581146744409</c:v>
                </c:pt>
                <c:pt idx="1">
                  <c:v>75.801749271137012</c:v>
                </c:pt>
                <c:pt idx="2">
                  <c:v>65.208940719144792</c:v>
                </c:pt>
                <c:pt idx="3">
                  <c:v>54.42176870748299</c:v>
                </c:pt>
                <c:pt idx="4">
                  <c:v>39.334305150631678</c:v>
                </c:pt>
                <c:pt idx="5">
                  <c:v>35.252672497570451</c:v>
                </c:pt>
                <c:pt idx="6">
                  <c:v>30.903790087463552</c:v>
                </c:pt>
                <c:pt idx="7">
                  <c:v>23.12925170068027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AE$21</c:f>
              <c:strCache>
                <c:ptCount val="1"/>
                <c:pt idx="0">
                  <c:v>Drought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AF$23:$AM$23</c:f>
                <c:numCache>
                  <c:formatCode>General</c:formatCode>
                  <c:ptCount val="8"/>
                  <c:pt idx="0">
                    <c:v>1.6750249514178883</c:v>
                  </c:pt>
                  <c:pt idx="1">
                    <c:v>2.3298977119644149</c:v>
                  </c:pt>
                  <c:pt idx="2">
                    <c:v>1.7915009388144174</c:v>
                  </c:pt>
                  <c:pt idx="3">
                    <c:v>1.9792040103126309</c:v>
                  </c:pt>
                  <c:pt idx="4">
                    <c:v>3.9984693945622003</c:v>
                  </c:pt>
                  <c:pt idx="5">
                    <c:v>3.7607262140755138</c:v>
                  </c:pt>
                  <c:pt idx="6">
                    <c:v>3.3531321096730666</c:v>
                  </c:pt>
                  <c:pt idx="7">
                    <c:v>2.4248721389678614</c:v>
                  </c:pt>
                </c:numCache>
              </c:numRef>
            </c:plus>
            <c:minus>
              <c:numRef>
                <c:f>Sheet1!$AF$23:$AM$23</c:f>
                <c:numCache>
                  <c:formatCode>General</c:formatCode>
                  <c:ptCount val="8"/>
                  <c:pt idx="0">
                    <c:v>1.6750249514178883</c:v>
                  </c:pt>
                  <c:pt idx="1">
                    <c:v>2.3298977119644149</c:v>
                  </c:pt>
                  <c:pt idx="2">
                    <c:v>1.7915009388144174</c:v>
                  </c:pt>
                  <c:pt idx="3">
                    <c:v>1.9792040103126309</c:v>
                  </c:pt>
                  <c:pt idx="4">
                    <c:v>3.9984693945622003</c:v>
                  </c:pt>
                  <c:pt idx="5">
                    <c:v>3.7607262140755138</c:v>
                  </c:pt>
                  <c:pt idx="6">
                    <c:v>3.3531321096730666</c:v>
                  </c:pt>
                  <c:pt idx="7">
                    <c:v>2.42487213896786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F$2:$AM$2</c:f>
              <c:strCache>
                <c:ptCount val="8"/>
                <c:pt idx="0">
                  <c:v>0 D</c:v>
                </c:pt>
                <c:pt idx="1">
                  <c:v>2 D</c:v>
                </c:pt>
                <c:pt idx="2">
                  <c:v>3 D</c:v>
                </c:pt>
                <c:pt idx="3">
                  <c:v>4 D</c:v>
                </c:pt>
                <c:pt idx="4">
                  <c:v>6 D</c:v>
                </c:pt>
                <c:pt idx="5">
                  <c:v>7 D</c:v>
                </c:pt>
                <c:pt idx="6">
                  <c:v>8 D</c:v>
                </c:pt>
                <c:pt idx="7">
                  <c:v>10 D</c:v>
                </c:pt>
              </c:strCache>
            </c:strRef>
          </c:cat>
          <c:val>
            <c:numRef>
              <c:f>Sheet1!$AF$21:$AM$21</c:f>
              <c:numCache>
                <c:formatCode>General</c:formatCode>
                <c:ptCount val="8"/>
                <c:pt idx="0">
                  <c:v>92.517006802721085</c:v>
                </c:pt>
                <c:pt idx="1">
                  <c:v>76.797862001943628</c:v>
                </c:pt>
                <c:pt idx="2">
                  <c:v>67.395529640427597</c:v>
                </c:pt>
                <c:pt idx="3">
                  <c:v>58.309037900874635</c:v>
                </c:pt>
                <c:pt idx="4">
                  <c:v>46.938775510204074</c:v>
                </c:pt>
                <c:pt idx="5">
                  <c:v>41.93391642371234</c:v>
                </c:pt>
                <c:pt idx="6">
                  <c:v>36.224489795918366</c:v>
                </c:pt>
                <c:pt idx="7">
                  <c:v>27.4295432458697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73928024"/>
        <c:axId val="171940568"/>
      </c:lineChart>
      <c:catAx>
        <c:axId val="173928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25000"/>
              </a:schemeClr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940568"/>
        <c:crosses val="autoZero"/>
        <c:auto val="1"/>
        <c:lblAlgn val="ctr"/>
        <c:lblOffset val="100"/>
        <c:noMultiLvlLbl val="0"/>
      </c:catAx>
      <c:valAx>
        <c:axId val="171940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Field capac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3928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267196310094219"/>
          <c:y val="6.4973492595671006E-2"/>
          <c:w val="0.57262409747410437"/>
          <c:h val="0.208797434697949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107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76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9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2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63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60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74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9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632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58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44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FCEFA-CF4C-49EB-8EF0-754D37501B38}" type="datetimeFigureOut">
              <a:rPr lang="en-US" smtClean="0"/>
              <a:t>5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" name="Content Placeholder 3"/>
          <p:cNvGraphicFramePr>
            <a:graphicFrameLocks/>
          </p:cNvGraphicFramePr>
          <p:nvPr>
            <p:extLst/>
          </p:nvPr>
        </p:nvGraphicFramePr>
        <p:xfrm>
          <a:off x="663265" y="3732605"/>
          <a:ext cx="5659833" cy="2501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3" name="TextBox 62"/>
          <p:cNvSpPr txBox="1"/>
          <p:nvPr/>
        </p:nvSpPr>
        <p:spPr>
          <a:xfrm>
            <a:off x="141430" y="3327587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92787" y="80383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29209" y="536015"/>
            <a:ext cx="6336969" cy="2705271"/>
            <a:chOff x="481665" y="1025507"/>
            <a:chExt cx="6336969" cy="2705271"/>
          </a:xfrm>
        </p:grpSpPr>
        <p:grpSp>
          <p:nvGrpSpPr>
            <p:cNvPr id="5" name="Group 4"/>
            <p:cNvGrpSpPr>
              <a:grpSpLocks noChangeAspect="1"/>
            </p:cNvGrpSpPr>
            <p:nvPr/>
          </p:nvGrpSpPr>
          <p:grpSpPr>
            <a:xfrm>
              <a:off x="481665" y="1025507"/>
              <a:ext cx="6336969" cy="2705271"/>
              <a:chOff x="2431009" y="1501816"/>
              <a:chExt cx="8448216" cy="3704104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431009" y="1501816"/>
                <a:ext cx="8104922" cy="3704104"/>
                <a:chOff x="2431009" y="1501816"/>
                <a:chExt cx="8104922" cy="3704104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2431009" y="1501816"/>
                  <a:ext cx="8104922" cy="3704104"/>
                  <a:chOff x="3116809" y="1515263"/>
                  <a:chExt cx="8104922" cy="3704104"/>
                </a:xfrm>
              </p:grpSpPr>
              <p:grpSp>
                <p:nvGrpSpPr>
                  <p:cNvPr id="21" name="Group 20"/>
                  <p:cNvGrpSpPr/>
                  <p:nvPr/>
                </p:nvGrpSpPr>
                <p:grpSpPr>
                  <a:xfrm>
                    <a:off x="3116809" y="1532473"/>
                    <a:ext cx="5532242" cy="3686894"/>
                    <a:chOff x="242833" y="4211122"/>
                    <a:chExt cx="4163921" cy="2253217"/>
                  </a:xfrm>
                </p:grpSpPr>
                <p:sp>
                  <p:nvSpPr>
                    <p:cNvPr id="27" name="Rectangle 26"/>
                    <p:cNvSpPr/>
                    <p:nvPr/>
                  </p:nvSpPr>
                  <p:spPr>
                    <a:xfrm>
                      <a:off x="1696719" y="4211122"/>
                      <a:ext cx="2710035" cy="222525"/>
                    </a:xfrm>
                    <a:prstGeom prst="rect">
                      <a:avLst/>
                    </a:prstGeom>
                    <a:solidFill>
                      <a:schemeClr val="bg2">
                        <a:lumMod val="75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5         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         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        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        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       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                                              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49" name="Group 48"/>
                    <p:cNvGrpSpPr/>
                    <p:nvPr/>
                  </p:nvGrpSpPr>
                  <p:grpSpPr>
                    <a:xfrm>
                      <a:off x="1834076" y="4726283"/>
                      <a:ext cx="2405732" cy="745404"/>
                      <a:chOff x="4203557" y="1989182"/>
                      <a:chExt cx="4276867" cy="1503024"/>
                    </a:xfrm>
                  </p:grpSpPr>
                  <p:grpSp>
                    <p:nvGrpSpPr>
                      <p:cNvPr id="55" name="Group 54"/>
                      <p:cNvGrpSpPr/>
                      <p:nvPr/>
                    </p:nvGrpSpPr>
                    <p:grpSpPr>
                      <a:xfrm>
                        <a:off x="4203557" y="1989182"/>
                        <a:ext cx="4276867" cy="1503024"/>
                        <a:chOff x="4203557" y="1660572"/>
                        <a:chExt cx="4276867" cy="1503024"/>
                      </a:xfrm>
                    </p:grpSpPr>
                    <p:grpSp>
                      <p:nvGrpSpPr>
                        <p:cNvPr id="57" name="Group 56"/>
                        <p:cNvGrpSpPr/>
                        <p:nvPr/>
                      </p:nvGrpSpPr>
                      <p:grpSpPr>
                        <a:xfrm>
                          <a:off x="4334402" y="1887789"/>
                          <a:ext cx="4146022" cy="1275807"/>
                          <a:chOff x="2860461" y="2861186"/>
                          <a:chExt cx="4146022" cy="1275807"/>
                        </a:xfrm>
                      </p:grpSpPr>
                      <p:cxnSp>
                        <p:nvCxnSpPr>
                          <p:cNvPr id="60" name="Straight Connector 59"/>
                          <p:cNvCxnSpPr/>
                          <p:nvPr/>
                        </p:nvCxnSpPr>
                        <p:spPr>
                          <a:xfrm>
                            <a:off x="6640721" y="4136993"/>
                            <a:ext cx="365762" cy="0"/>
                          </a:xfrm>
                          <a:prstGeom prst="line">
                            <a:avLst/>
                          </a:prstGeom>
                          <a:ln w="38100">
                            <a:solidFill>
                              <a:schemeClr val="tx1">
                                <a:lumMod val="95000"/>
                                <a:lumOff val="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61" name="Straight Connector 60"/>
                          <p:cNvCxnSpPr/>
                          <p:nvPr/>
                        </p:nvCxnSpPr>
                        <p:spPr>
                          <a:xfrm>
                            <a:off x="2860461" y="2861186"/>
                            <a:ext cx="3788347" cy="1265300"/>
                          </a:xfrm>
                          <a:prstGeom prst="line">
                            <a:avLst/>
                          </a:prstGeom>
                          <a:ln w="38100">
                            <a:solidFill>
                              <a:schemeClr val="tx1">
                                <a:lumMod val="95000"/>
                                <a:lumOff val="5000"/>
                              </a:schemeClr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58" name="Down Arrow 57"/>
                        <p:cNvSpPr/>
                        <p:nvPr/>
                      </p:nvSpPr>
                      <p:spPr>
                        <a:xfrm>
                          <a:off x="4203557" y="1660572"/>
                          <a:ext cx="225995" cy="168226"/>
                        </a:xfrm>
                        <a:prstGeom prst="downArrow">
                          <a:avLst/>
                        </a:prstGeom>
                        <a:solidFill>
                          <a:srgbClr val="1C1C1C"/>
                        </a:solidFill>
                        <a:ln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 sz="900" b="1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56" name="Up Arrow 55"/>
                      <p:cNvSpPr/>
                      <p:nvPr/>
                    </p:nvSpPr>
                    <p:spPr>
                      <a:xfrm>
                        <a:off x="4205588" y="2251108"/>
                        <a:ext cx="247343" cy="186544"/>
                      </a:xfrm>
                      <a:prstGeom prst="upArrow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9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29" name="Group 28"/>
                    <p:cNvGrpSpPr/>
                    <p:nvPr/>
                  </p:nvGrpSpPr>
                  <p:grpSpPr>
                    <a:xfrm>
                      <a:off x="1835217" y="5100472"/>
                      <a:ext cx="2404082" cy="624962"/>
                      <a:chOff x="4205588" y="2216400"/>
                      <a:chExt cx="4273923" cy="1111045"/>
                    </a:xfrm>
                  </p:grpSpPr>
                  <p:grpSp>
                    <p:nvGrpSpPr>
                      <p:cNvPr id="44" name="Group 43"/>
                      <p:cNvGrpSpPr/>
                      <p:nvPr/>
                    </p:nvGrpSpPr>
                    <p:grpSpPr>
                      <a:xfrm>
                        <a:off x="4334402" y="2216400"/>
                        <a:ext cx="4145109" cy="1111045"/>
                        <a:chOff x="2860461" y="2861187"/>
                        <a:chExt cx="4145109" cy="1111045"/>
                      </a:xfrm>
                    </p:grpSpPr>
                    <p:cxnSp>
                      <p:nvCxnSpPr>
                        <p:cNvPr id="47" name="Straight Connector 46"/>
                        <p:cNvCxnSpPr/>
                        <p:nvPr/>
                      </p:nvCxnSpPr>
                      <p:spPr>
                        <a:xfrm>
                          <a:off x="6639811" y="3971231"/>
                          <a:ext cx="365759" cy="0"/>
                        </a:xfrm>
                        <a:prstGeom prst="line">
                          <a:avLst/>
                        </a:prstGeom>
                        <a:ln w="3810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48" name="Straight Connector 47"/>
                        <p:cNvCxnSpPr/>
                        <p:nvPr/>
                      </p:nvCxnSpPr>
                      <p:spPr>
                        <a:xfrm>
                          <a:off x="2860461" y="2861187"/>
                          <a:ext cx="3788347" cy="1111045"/>
                        </a:xfrm>
                        <a:prstGeom prst="line">
                          <a:avLst/>
                        </a:prstGeom>
                        <a:ln w="38100">
                          <a:solidFill>
                            <a:schemeClr val="tx1">
                              <a:lumMod val="95000"/>
                              <a:lumOff val="5000"/>
                            </a:schemeClr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45" name="Up Arrow 44"/>
                      <p:cNvSpPr/>
                      <p:nvPr/>
                    </p:nvSpPr>
                    <p:spPr>
                      <a:xfrm>
                        <a:off x="4205588" y="2251108"/>
                        <a:ext cx="247343" cy="186544"/>
                      </a:xfrm>
                      <a:prstGeom prst="upArrow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9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30" name="Group 29"/>
                    <p:cNvGrpSpPr/>
                    <p:nvPr/>
                  </p:nvGrpSpPr>
                  <p:grpSpPr>
                    <a:xfrm>
                      <a:off x="1915313" y="5929629"/>
                      <a:ext cx="2339707" cy="7945"/>
                      <a:chOff x="3371486" y="3152482"/>
                      <a:chExt cx="4365297" cy="7945"/>
                    </a:xfrm>
                  </p:grpSpPr>
                  <p:cxnSp>
                    <p:nvCxnSpPr>
                      <p:cNvPr id="42" name="Straight Connector 41"/>
                      <p:cNvCxnSpPr/>
                      <p:nvPr/>
                    </p:nvCxnSpPr>
                    <p:spPr>
                      <a:xfrm>
                        <a:off x="3371486" y="3152482"/>
                        <a:ext cx="4365297" cy="0"/>
                      </a:xfrm>
                      <a:prstGeom prst="line">
                        <a:avLst/>
                      </a:prstGeom>
                      <a:ln w="3810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" name="Straight Connector 42"/>
                      <p:cNvCxnSpPr/>
                      <p:nvPr/>
                    </p:nvCxnSpPr>
                    <p:spPr>
                      <a:xfrm flipH="1" flipV="1">
                        <a:off x="7655518" y="3160427"/>
                        <a:ext cx="1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1" name="Down Arrow 30"/>
                    <p:cNvSpPr/>
                    <p:nvPr/>
                  </p:nvSpPr>
                  <p:spPr>
                    <a:xfrm>
                      <a:off x="1866063" y="5837952"/>
                      <a:ext cx="127122" cy="94627"/>
                    </a:xfrm>
                    <a:prstGeom prst="downArrow">
                      <a:avLst/>
                    </a:prstGeom>
                    <a:solidFill>
                      <a:srgbClr val="1C1C1C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32" name="Group 31"/>
                    <p:cNvGrpSpPr/>
                    <p:nvPr/>
                  </p:nvGrpSpPr>
                  <p:grpSpPr>
                    <a:xfrm>
                      <a:off x="1863393" y="6051217"/>
                      <a:ext cx="2386272" cy="107449"/>
                      <a:chOff x="3312701" y="3349382"/>
                      <a:chExt cx="4242257" cy="191020"/>
                    </a:xfrm>
                  </p:grpSpPr>
                  <p:cxnSp>
                    <p:nvCxnSpPr>
                      <p:cNvPr id="40" name="Straight Connector 39"/>
                      <p:cNvCxnSpPr/>
                      <p:nvPr/>
                    </p:nvCxnSpPr>
                    <p:spPr>
                      <a:xfrm>
                        <a:off x="3395479" y="3540402"/>
                        <a:ext cx="4159479" cy="0"/>
                      </a:xfrm>
                      <a:prstGeom prst="line">
                        <a:avLst/>
                      </a:prstGeom>
                      <a:ln w="38100"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1" name="Down Arrow 40"/>
                      <p:cNvSpPr/>
                      <p:nvPr/>
                    </p:nvSpPr>
                    <p:spPr>
                      <a:xfrm>
                        <a:off x="3312701" y="3349382"/>
                        <a:ext cx="221231" cy="165289"/>
                      </a:xfrm>
                      <a:prstGeom prst="downArrow">
                        <a:avLst/>
                      </a:prstGeom>
                      <a:solidFill>
                        <a:schemeClr val="accent3">
                          <a:lumMod val="20000"/>
                          <a:lumOff val="80000"/>
                        </a:schemeClr>
                      </a:solidFill>
                      <a:ln>
                        <a:solidFill>
                          <a:schemeClr val="tx1">
                            <a:lumMod val="95000"/>
                            <a:lumOff val="5000"/>
                          </a:schemeClr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900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33" name="Straight Connector 32"/>
                    <p:cNvCxnSpPr/>
                    <p:nvPr/>
                  </p:nvCxnSpPr>
                  <p:spPr>
                    <a:xfrm>
                      <a:off x="1915313" y="6382863"/>
                      <a:ext cx="2339707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242833" y="4746856"/>
                      <a:ext cx="1433507" cy="193157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Drought</a:t>
                      </a: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242833" y="4990636"/>
                      <a:ext cx="1433505" cy="193157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ught only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242834" y="5820561"/>
                      <a:ext cx="1452613" cy="193157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 only 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242834" y="6032754"/>
                      <a:ext cx="1452613" cy="193157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k 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242834" y="6271182"/>
                      <a:ext cx="1452613" cy="193157"/>
                    </a:xfrm>
                    <a:prstGeom prst="rect">
                      <a:avLst/>
                    </a:prstGeom>
                    <a:solidFill>
                      <a:schemeClr val="bg1">
                        <a:lumMod val="75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olute control</a:t>
                      </a:r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242833" y="4225411"/>
                      <a:ext cx="1420726" cy="193157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s</a:t>
                      </a:r>
                    </a:p>
                  </p:txBody>
                </p:sp>
              </p:grp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8800033" y="2501568"/>
                    <a:ext cx="2421698" cy="1024267"/>
                    <a:chOff x="9472383" y="2501568"/>
                    <a:chExt cx="2421698" cy="1024267"/>
                  </a:xfrm>
                </p:grpSpPr>
                <p:sp>
                  <p:nvSpPr>
                    <p:cNvPr id="15" name="Down Arrow 14"/>
                    <p:cNvSpPr/>
                    <p:nvPr/>
                  </p:nvSpPr>
                  <p:spPr>
                    <a:xfrm>
                      <a:off x="9472383" y="2608502"/>
                      <a:ext cx="168895" cy="136514"/>
                    </a:xfrm>
                    <a:prstGeom prst="downArrow">
                      <a:avLst/>
                    </a:prstGeom>
                    <a:solidFill>
                      <a:srgbClr val="1C1C1C"/>
                    </a:solidFill>
                    <a:ln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" name="Down Arrow 15"/>
                    <p:cNvSpPr/>
                    <p:nvPr/>
                  </p:nvSpPr>
                  <p:spPr>
                    <a:xfrm>
                      <a:off x="9497298" y="2974567"/>
                      <a:ext cx="165335" cy="152134"/>
                    </a:xfrm>
                    <a:prstGeom prst="downArrow">
                      <a:avLst/>
                    </a:prstGeom>
                    <a:solidFill>
                      <a:schemeClr val="accent3">
                        <a:lumMod val="20000"/>
                        <a:lumOff val="80000"/>
                      </a:schemeClr>
                    </a:solidFill>
                    <a:ln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7" name="Up Arrow 16"/>
                    <p:cNvSpPr/>
                    <p:nvPr/>
                  </p:nvSpPr>
                  <p:spPr>
                    <a:xfrm>
                      <a:off x="9486976" y="3293066"/>
                      <a:ext cx="184850" cy="171696"/>
                    </a:xfrm>
                    <a:prstGeom prst="upArrow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9655731" y="2501568"/>
                      <a:ext cx="1810519" cy="31605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 inoculation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9660215" y="2869121"/>
                      <a:ext cx="1511331" cy="31605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ter inoculation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9664697" y="3209776"/>
                      <a:ext cx="2229384" cy="31605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t of drought imposition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2" name="Down Arrow 11"/>
                  <p:cNvSpPr/>
                  <p:nvPr/>
                </p:nvSpPr>
                <p:spPr>
                  <a:xfrm>
                    <a:off x="3893641" y="1986277"/>
                    <a:ext cx="323411" cy="326902"/>
                  </a:xfrm>
                  <a:prstGeom prst="downArrow">
                    <a:avLst/>
                  </a:prstGeom>
                  <a:solidFill>
                    <a:schemeClr val="bg2">
                      <a:lumMod val="25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Left Arrow 12"/>
                  <p:cNvSpPr/>
                  <p:nvPr/>
                </p:nvSpPr>
                <p:spPr>
                  <a:xfrm>
                    <a:off x="8649053" y="1555974"/>
                    <a:ext cx="340529" cy="295832"/>
                  </a:xfrm>
                  <a:prstGeom prst="leftArrow">
                    <a:avLst/>
                  </a:prstGeom>
                  <a:solidFill>
                    <a:schemeClr val="bg2">
                      <a:lumMod val="25000"/>
                    </a:schemeClr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9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9065913" y="1515263"/>
                    <a:ext cx="1451493" cy="316059"/>
                  </a:xfrm>
                  <a:prstGeom prst="rect">
                    <a:avLst/>
                  </a:prstGeom>
                  <a:solidFill>
                    <a:schemeClr val="tx2">
                      <a:lumMod val="75000"/>
                    </a:schemeClr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 smtClean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ant Age (days)</a:t>
                    </a:r>
                    <a:endParaRPr lang="en-US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" name="TextBox 8"/>
                <p:cNvSpPr txBox="1"/>
                <p:nvPr/>
              </p:nvSpPr>
              <p:spPr>
                <a:xfrm>
                  <a:off x="8190097" y="3636231"/>
                  <a:ext cx="2028499" cy="316059"/>
                </a:xfrm>
                <a:prstGeom prst="rect">
                  <a:avLst/>
                </a:prstGeom>
                <a:solidFill>
                  <a:schemeClr val="tx2">
                    <a:lumMod val="75000"/>
                  </a:schemeClr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C=pot mix water status</a:t>
                  </a:r>
                  <a:endParaRPr lang="en-US" sz="9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" name="TextBox 6"/>
              <p:cNvSpPr txBox="1"/>
              <p:nvPr/>
            </p:nvSpPr>
            <p:spPr>
              <a:xfrm>
                <a:off x="8128823" y="4080259"/>
                <a:ext cx="2750402" cy="5056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lope indicates drop in pot-mix moisture content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1930589" y="1458664"/>
              <a:ext cx="495649" cy="215444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C=85</a:t>
              </a:r>
              <a:endPara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456258" y="1623282"/>
              <a:ext cx="495649" cy="215444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C=75</a:t>
              </a:r>
              <a:endPara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956527" y="1826000"/>
              <a:ext cx="495649" cy="215444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C=55</a:t>
              </a:r>
              <a:endPara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469496" y="2016018"/>
              <a:ext cx="495649" cy="215444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C=40</a:t>
              </a:r>
              <a:endPara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007865" y="2244136"/>
              <a:ext cx="495649" cy="215444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C=20</a:t>
              </a:r>
              <a:endPara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2" name="TextBox 71"/>
          <p:cNvSpPr txBox="1"/>
          <p:nvPr/>
        </p:nvSpPr>
        <p:spPr>
          <a:xfrm>
            <a:off x="796777" y="-17372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532057" y="6071441"/>
            <a:ext cx="2523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s post pathogen inoculati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76276" y="7025188"/>
            <a:ext cx="6481528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/>
              <a:t>Supplementary Figure S2:</a:t>
            </a:r>
            <a:r>
              <a:rPr lang="en-US" dirty="0" smtClean="0"/>
              <a:t> </a:t>
            </a:r>
            <a:r>
              <a:rPr lang="en-US" b="1" dirty="0"/>
              <a:t>Schematic representation of methodology used for</a:t>
            </a:r>
            <a:r>
              <a:rPr lang="en-US" dirty="0"/>
              <a:t> </a:t>
            </a:r>
            <a:r>
              <a:rPr lang="en-US" b="1" dirty="0"/>
              <a:t>imposition of pathogen infection followed by drought stress (PD). A)</a:t>
            </a:r>
            <a:r>
              <a:rPr lang="en-US" dirty="0"/>
              <a:t> Illustration of method used for combined stress imposition (PD). Pathogen was inoculated in 45 days old chickpea plants and the plants were subjected to water with-holding after 1 day of pathogen inoculation. The water with-holding was continued for 10 days till soil moisture content reaches to FC of 20%. The pathogen only inoculated plants were maintained at FC-80%. </a:t>
            </a:r>
            <a:r>
              <a:rPr lang="en-US" b="1" dirty="0"/>
              <a:t>B) </a:t>
            </a:r>
            <a:r>
              <a:rPr lang="en-US" dirty="0"/>
              <a:t>Graph shows gradual loss in FC during 10 days period of drought stress imposition in PD and drought stress. Data represents average of three replicates and error bar represents ± SEM. </a:t>
            </a:r>
            <a:r>
              <a:rPr lang="en-US" b="1" dirty="0"/>
              <a:t>Absolute control</a:t>
            </a:r>
            <a:r>
              <a:rPr lang="en-US" dirty="0"/>
              <a:t>: no drought, no pathogen infection; </a:t>
            </a:r>
            <a:r>
              <a:rPr lang="en-US" b="1" dirty="0"/>
              <a:t>Mock</a:t>
            </a:r>
            <a:r>
              <a:rPr lang="en-US" dirty="0"/>
              <a:t>: no drought, water infiltration; </a:t>
            </a:r>
            <a:r>
              <a:rPr lang="en-US" b="1" dirty="0"/>
              <a:t>Pathogen only</a:t>
            </a:r>
            <a:r>
              <a:rPr lang="en-US" dirty="0"/>
              <a:t>: no drought, pathogen infiltration; </a:t>
            </a:r>
            <a:r>
              <a:rPr lang="en-US" b="1" dirty="0"/>
              <a:t>Drought only</a:t>
            </a:r>
            <a:r>
              <a:rPr lang="en-US" dirty="0"/>
              <a:t>: drought stress, no pathogen infiltration; </a:t>
            </a:r>
            <a:r>
              <a:rPr lang="en-US" b="1" dirty="0"/>
              <a:t>PD</a:t>
            </a:r>
            <a:r>
              <a:rPr lang="en-US" dirty="0"/>
              <a:t>: pathogen infection followed by drought stress.</a:t>
            </a:r>
          </a:p>
        </p:txBody>
      </p:sp>
    </p:spTree>
    <p:extLst>
      <p:ext uri="{BB962C8B-B14F-4D97-AF65-F5344CB8AC3E}">
        <p14:creationId xmlns:p14="http://schemas.microsoft.com/office/powerpoint/2010/main" val="2171555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2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2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58A2B0F1-7133-4ACB-A974-55FB7265B5E9}"/>
</file>

<file path=customXml/itemProps2.xml><?xml version="1.0" encoding="utf-8"?>
<ds:datastoreItem xmlns:ds="http://schemas.openxmlformats.org/officeDocument/2006/customXml" ds:itemID="{464FB375-287B-4C89-A08A-6620C2012D21}"/>
</file>

<file path=customXml/itemProps3.xml><?xml version="1.0" encoding="utf-8"?>
<ds:datastoreItem xmlns:ds="http://schemas.openxmlformats.org/officeDocument/2006/customXml" ds:itemID="{99D9E233-683D-4F11-A131-964B312B3D3D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21</TotalTime>
  <Words>228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jita Sinha</dc:creator>
  <cp:lastModifiedBy>user</cp:lastModifiedBy>
  <cp:revision>287</cp:revision>
  <dcterms:created xsi:type="dcterms:W3CDTF">2015-08-17T12:23:28Z</dcterms:created>
  <dcterms:modified xsi:type="dcterms:W3CDTF">2016-05-12T16:52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